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4.wmf" ContentType="image/x-wmf"/>
  <Override PartName="/ppt/media/image5.png" ContentType="image/png"/>
  <Override PartName="/ppt/media/image2.jpeg" ContentType="image/jpeg"/>
  <Override PartName="/ppt/media/image3.jpeg" ContentType="image/jpeg"/>
  <Override PartName="/ppt/media/image6.png" ContentType="image/png"/>
  <Override PartName="/ppt/media/image7.png" ContentType="image/png"/>
  <Override PartName="/ppt/media/image8.png" ContentType="image/png"/>
  <Override PartName="/ppt/media/image9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907588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62DFC3-74FB-4916-8224-E1808B07157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FBBE89-4B1F-4FC0-B704-2C51C2E804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2427B0-EDF6-44D5-BC19-B6FC68C98E8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4A9B12-6CDC-4999-BCF2-2DC0BA4920E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17306D-922F-49D7-9C44-E277910650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345919-866F-4A22-A89B-0B68B6CDCC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04BE3D-6456-4134-998E-23EDEFEC87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24D322-95C1-420C-8E08-3163899A7B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77A969-C8AD-4865-8688-498463D1EC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CCC47B-990C-4D5D-B03B-ECA8AA9384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1402E0-C762-4792-9E68-3B071E99C7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3AF48F-337C-4AB0-8DE7-91F405FB19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244920"/>
            <a:ext cx="231120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244920"/>
            <a:ext cx="313668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244920"/>
            <a:ext cx="231156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6A0FBFD-8142-4FAD-8424-5B7F6200F61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wmf"/><Relationship Id="rId5" Type="http://schemas.openxmlformats.org/officeDocument/2006/relationships/image" Target="../media/image5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6.png"/><Relationship Id="rId9" Type="http://schemas.openxmlformats.org/officeDocument/2006/relationships/image" Target="../media/image7.png"/><Relationship Id="rId10" Type="http://schemas.openxmlformats.org/officeDocument/2006/relationships/image" Target="../media/image7.png"/><Relationship Id="rId11" Type="http://schemas.openxmlformats.org/officeDocument/2006/relationships/image" Target="../media/image8.png"/><Relationship Id="rId12" Type="http://schemas.openxmlformats.org/officeDocument/2006/relationships/image" Target="../media/image8.png"/><Relationship Id="rId13" Type="http://schemas.openxmlformats.org/officeDocument/2006/relationships/image" Target="../media/image9.jpeg"/><Relationship Id="rId14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69840" y="162000"/>
            <a:ext cx="9798120" cy="6126120"/>
            <a:chOff x="69840" y="162000"/>
            <a:chExt cx="9798120" cy="6126120"/>
          </a:xfrm>
        </p:grpSpPr>
        <p:sp>
          <p:nvSpPr>
            <p:cNvPr id="42" name=""/>
            <p:cNvSpPr/>
            <p:nvPr/>
          </p:nvSpPr>
          <p:spPr>
            <a:xfrm>
              <a:off x="311760" y="181080"/>
              <a:ext cx="3607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Arial Narrow"/>
                </a:rPr>
                <a:t>A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"/>
            <p:cNvGrpSpPr/>
            <p:nvPr/>
          </p:nvGrpSpPr>
          <p:grpSpPr>
            <a:xfrm>
              <a:off x="155160" y="927360"/>
              <a:ext cx="2508120" cy="1443240"/>
              <a:chOff x="155160" y="927360"/>
              <a:chExt cx="2508120" cy="1443240"/>
            </a:xfrm>
          </p:grpSpPr>
          <p:pic>
            <p:nvPicPr>
              <p:cNvPr id="44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203040" y="927360"/>
                <a:ext cx="1196280" cy="1422360"/>
              </a:xfrm>
              <a:prstGeom prst="rect">
                <a:avLst/>
              </a:prstGeom>
              <a:ln w="9360">
                <a:solidFill>
                  <a:srgbClr val="808080"/>
                </a:solidFill>
                <a:miter/>
              </a:ln>
            </p:spPr>
          </p:pic>
          <p:sp>
            <p:nvSpPr>
              <p:cNvPr id="45" name=""/>
              <p:cNvSpPr/>
              <p:nvPr/>
            </p:nvSpPr>
            <p:spPr>
              <a:xfrm>
                <a:off x="880560" y="1013040"/>
                <a:ext cx="570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ffffff"/>
                    </a:solidFill>
                    <a:latin typeface="Arial Narrow"/>
                  </a:rPr>
                  <a:t>AR19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161280" y="1432080"/>
                <a:ext cx="326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ffffff"/>
                    </a:solidFill>
                    <a:latin typeface="Arial Narrow"/>
                  </a:rPr>
                  <a:t>T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545760" y="1444680"/>
                <a:ext cx="326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ffffff"/>
                    </a:solidFill>
                    <a:latin typeface="Arial Narrow"/>
                  </a:rPr>
                  <a:t>T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995040" y="1476360"/>
                <a:ext cx="326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ffffff"/>
                    </a:solidFill>
                    <a:latin typeface="Arial Narrow"/>
                  </a:rPr>
                  <a:t>T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155160" y="1824120"/>
                <a:ext cx="397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ffffff"/>
                    </a:solidFill>
                    <a:latin typeface="Arial Narrow"/>
                  </a:rPr>
                  <a:t>T1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578520" y="1833840"/>
                <a:ext cx="397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ffffff"/>
                    </a:solidFill>
                    <a:latin typeface="Arial Narrow"/>
                  </a:rPr>
                  <a:t>T1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947160" y="1854360"/>
                <a:ext cx="397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ffffff"/>
                    </a:solidFill>
                    <a:latin typeface="Arial Narrow"/>
                  </a:rPr>
                  <a:t>T1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678960" y="2094120"/>
                <a:ext cx="570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ffffff"/>
                    </a:solidFill>
                    <a:latin typeface="Arial Narrow"/>
                  </a:rPr>
                  <a:t>AR27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3" name="" descr=""/>
              <p:cNvPicPr/>
              <p:nvPr/>
            </p:nvPicPr>
            <p:blipFill>
              <a:blip r:embed="rId2"/>
              <a:stretch/>
            </p:blipFill>
            <p:spPr>
              <a:xfrm>
                <a:off x="1447560" y="928800"/>
                <a:ext cx="1215720" cy="1422360"/>
              </a:xfrm>
              <a:prstGeom prst="rect">
                <a:avLst/>
              </a:prstGeom>
              <a:ln w="9360">
                <a:solidFill>
                  <a:srgbClr val="808080"/>
                </a:solidFill>
                <a:miter/>
              </a:ln>
            </p:spPr>
          </p:pic>
        </p:grpSp>
        <p:sp>
          <p:nvSpPr>
            <p:cNvPr id="54" name=""/>
            <p:cNvSpPr/>
            <p:nvPr/>
          </p:nvSpPr>
          <p:spPr>
            <a:xfrm>
              <a:off x="3630960" y="201600"/>
              <a:ext cx="3607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Arial Narrow"/>
                </a:rPr>
                <a:t>B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11760" y="3218040"/>
              <a:ext cx="3607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Arial Narrow"/>
                </a:rPr>
                <a:t>C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5792400" y="3910320"/>
              <a:ext cx="13892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000000"/>
                  </a:solidFill>
                  <a:latin typeface="Arial Narrow"/>
                </a:rPr>
                <a:t>TRANSFORMATION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000000"/>
                  </a:solidFill>
                  <a:latin typeface="Arial Narrow"/>
                </a:rPr>
                <a:t>     </a:t>
              </a:r>
              <a:r>
                <a:rPr b="0" lang="es-ES" sz="1200" spc="-1" strike="noStrike">
                  <a:solidFill>
                    <a:srgbClr val="000000"/>
                  </a:solidFill>
                  <a:latin typeface="Arial Narrow"/>
                </a:rPr>
                <a:t>(pILJ16-RhaR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4860720" y="4367520"/>
              <a:ext cx="5007240" cy="51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600" spc="-1" strike="noStrike">
                  <a:solidFill>
                    <a:srgbClr val="336600"/>
                  </a:solidFill>
                  <a:latin typeface="Arial"/>
                </a:rPr>
                <a:t>        </a:t>
              </a:r>
              <a:r>
                <a:rPr b="1" lang="es-ES" sz="1600" spc="-1" strike="noStrike">
                  <a:solidFill>
                    <a:srgbClr val="336600"/>
                  </a:solidFill>
                  <a:latin typeface="Arial"/>
                </a:rPr>
                <a:t>C2 (AR256) </a:t>
              </a:r>
              <a:r>
                <a:rPr b="0" lang="es-ES" sz="1400" spc="-1" strike="noStrike">
                  <a:solidFill>
                    <a:srgbClr val="000000"/>
                  </a:solidFill>
                  <a:latin typeface="Arial"/>
                </a:rPr>
                <a:t>and</a:t>
              </a:r>
              <a:r>
                <a:rPr b="1" lang="es-ES" sz="1400" spc="-1" strike="noStrike">
                  <a:solidFill>
                    <a:srgbClr val="336600"/>
                  </a:solidFill>
                  <a:latin typeface="Arial"/>
                </a:rPr>
                <a:t> </a:t>
              </a:r>
              <a:r>
                <a:rPr b="1" lang="es-ES" sz="1600" spc="-1" strike="noStrike">
                  <a:solidFill>
                    <a:srgbClr val="336600"/>
                  </a:solidFill>
                  <a:latin typeface="Arial"/>
                </a:rPr>
                <a:t>C33 (AR262)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000000"/>
                  </a:solidFill>
                  <a:latin typeface="Arial Narrow"/>
                </a:rPr>
                <a:t>         </a:t>
              </a:r>
              <a:r>
                <a:rPr b="0" lang="es-ES" sz="1200" spc="-1" strike="noStrike">
                  <a:solidFill>
                    <a:srgbClr val="000000"/>
                  </a:solidFill>
                  <a:latin typeface="Arial Narrow"/>
                </a:rPr>
                <a:t>(</a:t>
              </a:r>
              <a:r>
                <a:rPr b="0" i="1" lang="es-ES" sz="1200" spc="-1" strike="noStrike">
                  <a:solidFill>
                    <a:srgbClr val="000000"/>
                  </a:solidFill>
                  <a:latin typeface="Arial Narrow"/>
                </a:rPr>
                <a:t>riboB2</a:t>
              </a:r>
              <a:r>
                <a:rPr b="0" lang="es-ES" sz="1200" spc="-1" strike="noStrike">
                  <a:solidFill>
                    <a:srgbClr val="000000"/>
                  </a:solidFill>
                  <a:latin typeface="Arial Narrow"/>
                </a:rPr>
                <a:t>?,</a:t>
              </a:r>
              <a:r>
                <a:rPr b="0" i="1" lang="es-ES" sz="1200" spc="-1" strike="noStrike">
                  <a:solidFill>
                    <a:srgbClr val="000000"/>
                  </a:solidFill>
                  <a:latin typeface="Arial Narrow"/>
                </a:rPr>
                <a:t> rhaR</a:t>
              </a:r>
              <a:r>
                <a:rPr b="0" lang="es-ES" sz="1200" spc="-1" strike="noStrike">
                  <a:solidFill>
                    <a:srgbClr val="000000"/>
                  </a:solidFill>
                  <a:latin typeface="Arial Narrow"/>
                </a:rPr>
                <a:t>::Af</a:t>
              </a:r>
              <a:r>
                <a:rPr b="0" i="1" lang="es-ES" sz="1200" spc="-1" strike="noStrike">
                  <a:solidFill>
                    <a:srgbClr val="000000"/>
                  </a:solidFill>
                  <a:latin typeface="Arial Narrow"/>
                </a:rPr>
                <a:t>riboB</a:t>
              </a:r>
              <a:r>
                <a:rPr b="0" lang="es-ES" sz="1200" spc="-1" strike="noStrike">
                  <a:solidFill>
                    <a:srgbClr val="000000"/>
                  </a:solidFill>
                  <a:latin typeface="Arial Narrow"/>
                </a:rPr>
                <a:t>, </a:t>
              </a:r>
              <a:r>
                <a:rPr b="0" i="1" lang="es-ES" sz="1200" spc="-1" strike="noStrike">
                  <a:solidFill>
                    <a:srgbClr val="000000"/>
                  </a:solidFill>
                  <a:latin typeface="Arial Narrow"/>
                </a:rPr>
                <a:t>metG1, biA1, argB2</a:t>
              </a:r>
              <a:r>
                <a:rPr b="0" lang="es-ES" sz="1200" spc="-1" strike="noStrike">
                  <a:solidFill>
                    <a:srgbClr val="000000"/>
                  </a:solidFill>
                  <a:latin typeface="Arial Narrow"/>
                </a:rPr>
                <a:t>, pILJ16-RhaR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6933600" y="3559320"/>
              <a:ext cx="13741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600" spc="-1" strike="noStrike">
                  <a:solidFill>
                    <a:srgbClr val="cc3300"/>
                  </a:solidFill>
                  <a:latin typeface="Arial"/>
                </a:rPr>
                <a:t>AR237 (H23)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9" name=""/>
            <p:cNvGrpSpPr/>
            <p:nvPr/>
          </p:nvGrpSpPr>
          <p:grpSpPr>
            <a:xfrm>
              <a:off x="1687320" y="4965840"/>
              <a:ext cx="2692080" cy="1295280"/>
              <a:chOff x="1687320" y="4965840"/>
              <a:chExt cx="2692080" cy="1295280"/>
            </a:xfrm>
          </p:grpSpPr>
          <p:sp>
            <p:nvSpPr>
              <p:cNvPr id="60" name=""/>
              <p:cNvSpPr/>
              <p:nvPr/>
            </p:nvSpPr>
            <p:spPr>
              <a:xfrm>
                <a:off x="3058920" y="4965840"/>
                <a:ext cx="1295280" cy="12952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1" name="Picture 3" descr="C:\Users\Ester\Documents\IATA\RC6\Fotos MUR disruptos &amp; complementados\20121102_082542.jpg"/>
              <p:cNvPicPr/>
              <p:nvPr/>
            </p:nvPicPr>
            <p:blipFill>
              <a:blip r:embed="rId3"/>
              <a:srcRect l="14178" t="6670" r="17493" b="2219"/>
              <a:stretch/>
            </p:blipFill>
            <p:spPr>
              <a:xfrm>
                <a:off x="1687320" y="4965840"/>
                <a:ext cx="1295280" cy="1295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2" name=""/>
              <p:cNvSpPr/>
              <p:nvPr/>
            </p:nvSpPr>
            <p:spPr>
              <a:xfrm>
                <a:off x="3058920" y="4965840"/>
                <a:ext cx="1295280" cy="129528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3" name=""/>
              <p:cNvGrpSpPr/>
              <p:nvPr/>
            </p:nvGrpSpPr>
            <p:grpSpPr>
              <a:xfrm>
                <a:off x="3051000" y="5106960"/>
                <a:ext cx="1328400" cy="965160"/>
                <a:chOff x="3051000" y="5106960"/>
                <a:chExt cx="1328400" cy="965160"/>
              </a:xfrm>
            </p:grpSpPr>
            <p:sp>
              <p:nvSpPr>
                <p:cNvPr id="64" name=""/>
                <p:cNvSpPr/>
                <p:nvPr/>
              </p:nvSpPr>
              <p:spPr>
                <a:xfrm>
                  <a:off x="3213360" y="5106960"/>
                  <a:ext cx="4305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 Narrow"/>
                    </a:rPr>
                    <a:t>AR4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"/>
                <p:cNvSpPr/>
                <p:nvPr/>
              </p:nvSpPr>
              <p:spPr>
                <a:xfrm>
                  <a:off x="3809880" y="5106960"/>
                  <a:ext cx="3268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333399"/>
                      </a:solidFill>
                      <a:latin typeface="Arial Narrow"/>
                    </a:rPr>
                    <a:t>T4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"/>
                <p:cNvSpPr/>
                <p:nvPr/>
              </p:nvSpPr>
              <p:spPr>
                <a:xfrm>
                  <a:off x="3051000" y="5430240"/>
                  <a:ext cx="3409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ff3300"/>
                      </a:solidFill>
                      <a:latin typeface="Arial Narrow"/>
                    </a:rPr>
                    <a:t>H8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"/>
                <p:cNvSpPr/>
                <p:nvPr/>
              </p:nvSpPr>
              <p:spPr>
                <a:xfrm>
                  <a:off x="3311640" y="5430240"/>
                  <a:ext cx="4107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ff3300"/>
                      </a:solidFill>
                      <a:latin typeface="Arial Narrow"/>
                    </a:rPr>
                    <a:t>H23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"/>
                <p:cNvSpPr/>
                <p:nvPr/>
              </p:nvSpPr>
              <p:spPr>
                <a:xfrm>
                  <a:off x="3645000" y="5430240"/>
                  <a:ext cx="4107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ff3300"/>
                      </a:solidFill>
                      <a:latin typeface="Arial Narrow"/>
                    </a:rPr>
                    <a:t>H1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"/>
                <p:cNvSpPr/>
                <p:nvPr/>
              </p:nvSpPr>
              <p:spPr>
                <a:xfrm>
                  <a:off x="3968640" y="5430240"/>
                  <a:ext cx="4107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ff3300"/>
                      </a:solidFill>
                      <a:latin typeface="Arial Narrow"/>
                    </a:rPr>
                    <a:t>H19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"/>
                <p:cNvSpPr/>
                <p:nvPr/>
              </p:nvSpPr>
              <p:spPr>
                <a:xfrm>
                  <a:off x="3467160" y="5795640"/>
                  <a:ext cx="5007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 Narrow"/>
                    </a:rPr>
                    <a:t>AR7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71" name=""/>
            <p:cNvSpPr/>
            <p:nvPr/>
          </p:nvSpPr>
          <p:spPr>
            <a:xfrm>
              <a:off x="69840" y="3822840"/>
              <a:ext cx="3013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000000"/>
                  </a:solidFill>
                  <a:latin typeface="Arial Narrow"/>
                </a:rPr>
                <a:t>(</a:t>
              </a:r>
              <a:r>
                <a:rPr b="0" i="1" lang="es-ES" sz="1200" spc="-1" strike="noStrike">
                  <a:solidFill>
                    <a:srgbClr val="000000"/>
                  </a:solidFill>
                  <a:latin typeface="Arial Narrow"/>
                </a:rPr>
                <a:t>argB2,</a:t>
              </a:r>
              <a:r>
                <a:rPr b="0" lang="es-ES" sz="1200" spc="-1" strike="noStrike">
                  <a:solidFill>
                    <a:srgbClr val="000000"/>
                  </a:solidFill>
                  <a:latin typeface="Arial Narrow"/>
                </a:rPr>
                <a:t> </a:t>
              </a:r>
              <a:r>
                <a:rPr b="0" i="1" lang="es-ES" sz="1200" spc="-1" strike="noStrike">
                  <a:solidFill>
                    <a:srgbClr val="000000"/>
                  </a:solidFill>
                  <a:latin typeface="Arial Narrow"/>
                </a:rPr>
                <a:t>nkuA::argB, riboB2, rhaR::AfriboB, pyroA4</a:t>
              </a:r>
              <a:r>
                <a:rPr b="0" lang="es-ES" sz="1200" spc="-1" strike="noStrike">
                  <a:solidFill>
                    <a:srgbClr val="000000"/>
                  </a:solidFill>
                  <a:latin typeface="Arial Narrow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1716120" y="3556080"/>
              <a:ext cx="2128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600" spc="-1" strike="noStrike">
                  <a:solidFill>
                    <a:srgbClr val="333399"/>
                  </a:solidFill>
                  <a:latin typeface="Arial"/>
                </a:rPr>
                <a:t>T4 (</a:t>
              </a:r>
              <a:r>
                <a:rPr b="1" lang="es-ES" sz="1800" spc="-1" strike="noStrike">
                  <a:solidFill>
                    <a:srgbClr val="333399"/>
                  </a:solidFill>
                  <a:latin typeface="Arial"/>
                </a:rPr>
                <a:t>AR225</a:t>
              </a:r>
              <a:r>
                <a:rPr b="1" lang="es-ES" sz="1600" spc="-1" strike="noStrike">
                  <a:solidFill>
                    <a:srgbClr val="333399"/>
                  </a:solidFill>
                  <a:latin typeface="Arial"/>
                </a:rPr>
                <a:t>)</a:t>
              </a:r>
              <a:r>
                <a:rPr b="0" lang="es-ES" sz="1600" spc="-1" strike="noStrike">
                  <a:solidFill>
                    <a:srgbClr val="cc3300"/>
                  </a:solidFill>
                  <a:latin typeface="Arial"/>
                </a:rPr>
                <a:t>  </a:t>
              </a:r>
              <a:r>
                <a:rPr b="1" lang="es-ES" sz="1600" spc="-1" strike="noStrike">
                  <a:solidFill>
                    <a:srgbClr val="000000"/>
                  </a:solidFill>
                  <a:latin typeface="Arial"/>
                </a:rPr>
                <a:t>x </a:t>
              </a:r>
              <a:r>
                <a:rPr b="0" lang="es-ES" sz="1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s-ES" sz="1600" spc="-1" strike="noStrike">
                  <a:solidFill>
                    <a:srgbClr val="000000"/>
                  </a:solidFill>
                  <a:latin typeface="Arial"/>
                </a:rPr>
                <a:t>AR4</a:t>
              </a:r>
              <a:r>
                <a:rPr b="0" lang="es-ES" sz="14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3093840" y="4070520"/>
              <a:ext cx="3240" cy="361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1668600" y="4368960"/>
              <a:ext cx="2852280" cy="51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600" spc="-1" strike="noStrike">
                  <a:solidFill>
                    <a:srgbClr val="cc3300"/>
                  </a:solidFill>
                  <a:latin typeface="Arial"/>
                </a:rPr>
                <a:t>AR234 (H8)</a:t>
              </a:r>
              <a:r>
                <a:rPr b="0" lang="es-ES" sz="1400" spc="-1" strike="noStrike">
                  <a:solidFill>
                    <a:srgbClr val="000000"/>
                  </a:solidFill>
                  <a:latin typeface="Arial"/>
                </a:rPr>
                <a:t> and </a:t>
              </a:r>
              <a:r>
                <a:rPr b="1" lang="es-ES" sz="1600" spc="-1" strike="noStrike">
                  <a:solidFill>
                    <a:srgbClr val="cc3300"/>
                  </a:solidFill>
                  <a:latin typeface="Arial"/>
                </a:rPr>
                <a:t>AR237 (H23)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000000"/>
                  </a:solidFill>
                  <a:latin typeface="Arial Narrow"/>
                </a:rPr>
                <a:t>(</a:t>
              </a:r>
              <a:r>
                <a:rPr b="0" i="1" lang="es-ES" sz="1200" spc="-1" strike="noStrike">
                  <a:solidFill>
                    <a:srgbClr val="000000"/>
                  </a:solidFill>
                  <a:latin typeface="Arial Narrow"/>
                </a:rPr>
                <a:t>riboB2</a:t>
              </a:r>
              <a:r>
                <a:rPr b="0" lang="es-ES" sz="1200" spc="-1" strike="noStrike">
                  <a:solidFill>
                    <a:srgbClr val="000000"/>
                  </a:solidFill>
                  <a:latin typeface="Arial Narrow"/>
                </a:rPr>
                <a:t>?, </a:t>
              </a:r>
              <a:r>
                <a:rPr b="0" i="1" lang="es-ES" sz="1200" spc="-1" strike="noStrike">
                  <a:solidFill>
                    <a:srgbClr val="000000"/>
                  </a:solidFill>
                  <a:latin typeface="Arial Narrow"/>
                </a:rPr>
                <a:t>rhaR</a:t>
              </a:r>
              <a:r>
                <a:rPr b="0" lang="es-ES" sz="1200" spc="-1" strike="noStrike">
                  <a:solidFill>
                    <a:srgbClr val="000000"/>
                  </a:solidFill>
                  <a:latin typeface="Arial Narrow"/>
                </a:rPr>
                <a:t>::Af</a:t>
              </a:r>
              <a:r>
                <a:rPr b="0" i="1" lang="es-ES" sz="1200" spc="-1" strike="noStrike">
                  <a:solidFill>
                    <a:srgbClr val="000000"/>
                  </a:solidFill>
                  <a:latin typeface="Arial Narrow"/>
                </a:rPr>
                <a:t>riboB</a:t>
              </a:r>
              <a:r>
                <a:rPr b="0" lang="es-ES" sz="1200" spc="-1" strike="noStrike">
                  <a:solidFill>
                    <a:srgbClr val="000000"/>
                  </a:solidFill>
                  <a:latin typeface="Arial Narrow"/>
                </a:rPr>
                <a:t>, </a:t>
              </a:r>
              <a:r>
                <a:rPr b="0" i="1" lang="es-ES" sz="1200" spc="-1" strike="noStrike">
                  <a:solidFill>
                    <a:srgbClr val="000000"/>
                  </a:solidFill>
                  <a:latin typeface="Arial Narrow"/>
                </a:rPr>
                <a:t>metG1</a:t>
              </a:r>
              <a:r>
                <a:rPr b="0" lang="es-ES" sz="1200" spc="-1" strike="noStrike">
                  <a:solidFill>
                    <a:srgbClr val="000000"/>
                  </a:solidFill>
                  <a:latin typeface="Arial Narrow"/>
                </a:rPr>
                <a:t>, </a:t>
              </a:r>
              <a:r>
                <a:rPr b="0" i="1" lang="es-ES" sz="1200" spc="-1" strike="noStrike">
                  <a:solidFill>
                    <a:srgbClr val="000000"/>
                  </a:solidFill>
                  <a:latin typeface="Arial Narrow"/>
                </a:rPr>
                <a:t>biA1</a:t>
              </a:r>
              <a:r>
                <a:rPr b="0" lang="es-ES" sz="1200" spc="-1" strike="noStrike">
                  <a:solidFill>
                    <a:srgbClr val="000000"/>
                  </a:solidFill>
                  <a:latin typeface="Arial Narrow"/>
                </a:rPr>
                <a:t>, </a:t>
              </a:r>
              <a:r>
                <a:rPr b="0" i="1" lang="es-ES" sz="1200" spc="-1" strike="noStrike">
                  <a:solidFill>
                    <a:srgbClr val="000000"/>
                  </a:solidFill>
                  <a:latin typeface="Arial Narrow"/>
                </a:rPr>
                <a:t>argB2</a:t>
              </a:r>
              <a:r>
                <a:rPr b="0" lang="es-ES" sz="1200" spc="-1" strike="noStrike">
                  <a:solidFill>
                    <a:srgbClr val="000000"/>
                  </a:solidFill>
                  <a:latin typeface="Arial Narrow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084120" y="3814920"/>
              <a:ext cx="1401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000000"/>
                  </a:solidFill>
                  <a:latin typeface="Arial Narrow"/>
                </a:rPr>
                <a:t> </a:t>
              </a:r>
              <a:r>
                <a:rPr b="0" lang="es-ES" sz="1200" spc="-1" strike="noStrike">
                  <a:solidFill>
                    <a:srgbClr val="000000"/>
                  </a:solidFill>
                  <a:latin typeface="Arial Narrow"/>
                </a:rPr>
                <a:t>(</a:t>
              </a:r>
              <a:r>
                <a:rPr b="0" i="1" lang="es-ES" sz="1200" spc="-1" strike="noStrike">
                  <a:solidFill>
                    <a:srgbClr val="000000"/>
                  </a:solidFill>
                  <a:latin typeface="Arial Narrow"/>
                </a:rPr>
                <a:t>metG1, biA1, argB2</a:t>
              </a:r>
              <a:r>
                <a:rPr b="0" lang="es-ES" sz="1200" spc="-1" strike="noStrike">
                  <a:solidFill>
                    <a:srgbClr val="000000"/>
                  </a:solidFill>
                  <a:latin typeface="Arial Narrow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8599680" y="5550120"/>
              <a:ext cx="1072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 Narrow"/>
                </a:rPr>
                <a:t>Complermente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5950440" y="3216240"/>
              <a:ext cx="3607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Arial Narrow"/>
                </a:rPr>
                <a:t>D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7372440" y="3980160"/>
              <a:ext cx="2880" cy="361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8427960" y="5321520"/>
              <a:ext cx="223920" cy="738000"/>
            </a:xfrm>
            <a:custGeom>
              <a:avLst/>
              <a:gdLst>
                <a:gd name="textAreaLeft" fmla="*/ 0 w 223920"/>
                <a:gd name="textAreaRight" fmla="*/ 80640 w 223920"/>
                <a:gd name="textAreaTop" fmla="*/ 19080 h 738000"/>
                <a:gd name="textAreaBottom" fmla="*/ 718920 h 738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16200" y="10800"/>
                    <a:pt x="21600" y="10800"/>
                  </a:cubicBezTo>
                  <a:cubicBezTo>
                    <a:pt x="162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7041960" y="4970520"/>
              <a:ext cx="1282680" cy="1295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7048440" y="4983480"/>
              <a:ext cx="1274760" cy="127476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2" name="" descr=""/>
            <p:cNvPicPr/>
            <p:nvPr/>
          </p:nvPicPr>
          <p:blipFill>
            <a:blip r:embed="rId4"/>
            <a:stretch/>
          </p:blipFill>
          <p:spPr>
            <a:xfrm>
              <a:off x="5680080" y="4954680"/>
              <a:ext cx="1306440" cy="1308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3" name=""/>
            <p:cNvSpPr/>
            <p:nvPr/>
          </p:nvSpPr>
          <p:spPr>
            <a:xfrm>
              <a:off x="7275960" y="5105520"/>
              <a:ext cx="279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333399"/>
                  </a:solidFill>
                  <a:latin typeface="Arial Narrow"/>
                </a:rPr>
                <a:t>T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7701120" y="5131080"/>
              <a:ext cx="34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Narrow"/>
                </a:rPr>
                <a:t>AR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7518240" y="6072480"/>
              <a:ext cx="33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cc3300"/>
                  </a:solidFill>
                  <a:latin typeface="Arial Narrow"/>
                </a:rPr>
                <a:t>H2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7470720" y="5648400"/>
              <a:ext cx="33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336600"/>
                  </a:solidFill>
                  <a:latin typeface="Arial Narrow"/>
                </a:rPr>
                <a:t>C3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7266600" y="5438880"/>
              <a:ext cx="289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336600"/>
                  </a:solidFill>
                  <a:latin typeface="Arial Narrow"/>
                </a:rPr>
                <a:t>C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7199280" y="5307120"/>
              <a:ext cx="763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7047000" y="5335560"/>
              <a:ext cx="269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7275600" y="5335560"/>
              <a:ext cx="269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7504200" y="5340600"/>
              <a:ext cx="269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7756560" y="5340600"/>
              <a:ext cx="269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7385040" y="5307120"/>
              <a:ext cx="763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7599240" y="5307120"/>
              <a:ext cx="763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7842240" y="5307120"/>
              <a:ext cx="763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8051760" y="5307120"/>
              <a:ext cx="763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8066160" y="5483520"/>
              <a:ext cx="759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8075520" y="5678640"/>
              <a:ext cx="763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7146720" y="5678640"/>
              <a:ext cx="763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7637400" y="5873760"/>
              <a:ext cx="763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7856640" y="5873760"/>
              <a:ext cx="759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8080200" y="5873760"/>
              <a:ext cx="763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7918560" y="6031080"/>
              <a:ext cx="759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7508880" y="5540400"/>
              <a:ext cx="269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7761600" y="5540400"/>
              <a:ext cx="269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7066080" y="5735880"/>
              <a:ext cx="269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7294680" y="5735880"/>
              <a:ext cx="269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7294680" y="5888160"/>
              <a:ext cx="269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7275600" y="5991480"/>
              <a:ext cx="33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336600"/>
                  </a:solidFill>
                  <a:latin typeface="Arial Narrow"/>
                </a:rPr>
                <a:t>C3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7642080" y="6121440"/>
              <a:ext cx="763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7375320" y="5159520"/>
              <a:ext cx="763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7742520" y="5021280"/>
              <a:ext cx="269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7275600" y="5540400"/>
              <a:ext cx="269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4" name=""/>
            <p:cNvGrpSpPr/>
            <p:nvPr/>
          </p:nvGrpSpPr>
          <p:grpSpPr>
            <a:xfrm>
              <a:off x="2939040" y="901800"/>
              <a:ext cx="3041640" cy="1561320"/>
              <a:chOff x="2939040" y="901800"/>
              <a:chExt cx="3041640" cy="1561320"/>
            </a:xfrm>
          </p:grpSpPr>
          <p:sp>
            <p:nvSpPr>
              <p:cNvPr id="115" name=""/>
              <p:cNvSpPr/>
              <p:nvPr/>
            </p:nvSpPr>
            <p:spPr>
              <a:xfrm>
                <a:off x="3417840" y="1305000"/>
                <a:ext cx="2488680" cy="0"/>
              </a:xfrm>
              <a:prstGeom prst="line">
                <a:avLst/>
              </a:prstGeom>
              <a:ln w="284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2939040" y="1162080"/>
                <a:ext cx="514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 Narrow"/>
                  </a:rPr>
                  <a:t>Chr V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3411360" y="2019240"/>
                <a:ext cx="2545920" cy="0"/>
              </a:xfrm>
              <a:prstGeom prst="line">
                <a:avLst/>
              </a:prstGeom>
              <a:ln w="284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3978000" y="1339920"/>
                <a:ext cx="185400" cy="63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 flipH="1">
                <a:off x="3957840" y="1346040"/>
                <a:ext cx="212040" cy="635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20" name=""/>
              <p:cNvGrpSpPr/>
              <p:nvPr/>
            </p:nvGrpSpPr>
            <p:grpSpPr>
              <a:xfrm>
                <a:off x="5267880" y="1344600"/>
                <a:ext cx="212400" cy="641520"/>
                <a:chOff x="5267880" y="1344600"/>
                <a:chExt cx="212400" cy="641520"/>
              </a:xfrm>
            </p:grpSpPr>
            <p:sp>
              <p:nvSpPr>
                <p:cNvPr id="121" name=""/>
                <p:cNvSpPr/>
                <p:nvPr/>
              </p:nvSpPr>
              <p:spPr>
                <a:xfrm>
                  <a:off x="5287680" y="1344600"/>
                  <a:ext cx="185040" cy="6318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" name=""/>
                <p:cNvSpPr/>
                <p:nvPr/>
              </p:nvSpPr>
              <p:spPr>
                <a:xfrm flipH="1">
                  <a:off x="5267880" y="1351080"/>
                  <a:ext cx="212400" cy="6350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23" name=""/>
              <p:cNvSpPr/>
              <p:nvPr/>
            </p:nvSpPr>
            <p:spPr>
              <a:xfrm>
                <a:off x="3857400" y="1305000"/>
                <a:ext cx="372600" cy="0"/>
              </a:xfrm>
              <a:prstGeom prst="line">
                <a:avLst/>
              </a:prstGeom>
              <a:ln w="57240">
                <a:solidFill>
                  <a:srgbClr val="3366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5233680" y="1308240"/>
                <a:ext cx="375840" cy="0"/>
              </a:xfrm>
              <a:prstGeom prst="line">
                <a:avLst/>
              </a:prstGeom>
              <a:ln w="57240">
                <a:solidFill>
                  <a:srgbClr val="3366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 flipH="1">
                <a:off x="4300200" y="1500120"/>
                <a:ext cx="188640" cy="0"/>
              </a:xfrm>
              <a:prstGeom prst="line">
                <a:avLst/>
              </a:prstGeom>
              <a:ln w="28440">
                <a:solidFill>
                  <a:srgbClr val="3366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 flipH="1">
                <a:off x="4271760" y="2224080"/>
                <a:ext cx="236160" cy="0"/>
              </a:xfrm>
              <a:prstGeom prst="line">
                <a:avLst/>
              </a:prstGeom>
              <a:ln w="28440">
                <a:solidFill>
                  <a:srgbClr val="cc33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2939040" y="1871640"/>
                <a:ext cx="514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 Narrow"/>
                  </a:rPr>
                  <a:t>Chr V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3862080" y="2021040"/>
                <a:ext cx="372960" cy="0"/>
              </a:xfrm>
              <a:prstGeom prst="line">
                <a:avLst/>
              </a:prstGeom>
              <a:ln w="57240">
                <a:solidFill>
                  <a:srgbClr val="3366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5132160" y="2019240"/>
                <a:ext cx="429840" cy="0"/>
              </a:xfrm>
              <a:prstGeom prst="line">
                <a:avLst/>
              </a:prstGeom>
              <a:ln w="57240">
                <a:solidFill>
                  <a:srgbClr val="3366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4292280" y="1073160"/>
                <a:ext cx="887040" cy="468360"/>
              </a:xfrm>
              <a:prstGeom prst="rightArrow">
                <a:avLst>
                  <a:gd name="adj1" fmla="val 50000"/>
                  <a:gd name="adj2" fmla="val 47348"/>
                </a:avLst>
              </a:prstGeom>
              <a:gradFill rotWithShape="0">
                <a:gsLst>
                  <a:gs pos="0">
                    <a:srgbClr val="336600"/>
                  </a:gs>
                  <a:gs pos="50000">
                    <a:srgbClr val="ffffff"/>
                  </a:gs>
                  <a:gs pos="100000">
                    <a:srgbClr val="336600"/>
                  </a:gs>
                </a:gsLst>
                <a:lin ang="5400000"/>
              </a:gradFill>
              <a:ln w="9360">
                <a:solidFill>
                  <a:srgbClr val="3366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4448160" y="1155600"/>
                <a:ext cx="548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s-ES" sz="1200" spc="-1" strike="noStrike">
                    <a:solidFill>
                      <a:srgbClr val="000000"/>
                    </a:solidFill>
                    <a:latin typeface="Arial Narrow"/>
                  </a:rPr>
                  <a:t>rha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4225680" y="1787400"/>
                <a:ext cx="975960" cy="468360"/>
              </a:xfrm>
              <a:prstGeom prst="rightArrow">
                <a:avLst>
                  <a:gd name="adj1" fmla="val 50000"/>
                  <a:gd name="adj2" fmla="val 52095"/>
                </a:avLst>
              </a:prstGeom>
              <a:gradFill rotWithShape="0">
                <a:gsLst>
                  <a:gs pos="0">
                    <a:srgbClr val="cc3300"/>
                  </a:gs>
                  <a:gs pos="100000">
                    <a:srgbClr val="ffffff"/>
                  </a:gs>
                </a:gsLst>
                <a:lin ang="5400000"/>
              </a:gradFill>
              <a:ln w="9360">
                <a:solidFill>
                  <a:srgbClr val="cc33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4313520" y="1874880"/>
                <a:ext cx="637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s-ES" sz="1200" spc="-1" strike="noStrike">
                    <a:solidFill>
                      <a:srgbClr val="000000"/>
                    </a:solidFill>
                    <a:latin typeface="Arial Narrow"/>
                  </a:rPr>
                  <a:t>Afribo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4266720" y="2201760"/>
                <a:ext cx="3268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 Narrow"/>
                  </a:rPr>
                  <a:t>B1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4273200" y="1474920"/>
                <a:ext cx="3268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 Narrow"/>
                  </a:rPr>
                  <a:t>R1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36" name=""/>
              <p:cNvGrpSpPr/>
              <p:nvPr/>
            </p:nvGrpSpPr>
            <p:grpSpPr>
              <a:xfrm>
                <a:off x="3476160" y="992160"/>
                <a:ext cx="2504520" cy="601200"/>
                <a:chOff x="3476160" y="992160"/>
                <a:chExt cx="2504520" cy="601200"/>
              </a:xfrm>
            </p:grpSpPr>
            <p:sp>
              <p:nvSpPr>
                <p:cNvPr id="137" name=""/>
                <p:cNvSpPr/>
                <p:nvPr/>
              </p:nvSpPr>
              <p:spPr>
                <a:xfrm>
                  <a:off x="3568320" y="1219320"/>
                  <a:ext cx="236160" cy="0"/>
                </a:xfrm>
                <a:prstGeom prst="line">
                  <a:avLst/>
                </a:prstGeom>
                <a:ln w="2844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" name=""/>
                <p:cNvSpPr/>
                <p:nvPr/>
              </p:nvSpPr>
              <p:spPr>
                <a:xfrm flipH="1">
                  <a:off x="5639760" y="1378080"/>
                  <a:ext cx="236160" cy="0"/>
                </a:xfrm>
                <a:prstGeom prst="line">
                  <a:avLst/>
                </a:prstGeom>
                <a:ln w="2844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" name=""/>
                <p:cNvSpPr/>
                <p:nvPr/>
              </p:nvSpPr>
              <p:spPr>
                <a:xfrm>
                  <a:off x="3476160" y="992160"/>
                  <a:ext cx="326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R0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" name=""/>
                <p:cNvSpPr/>
                <p:nvPr/>
              </p:nvSpPr>
              <p:spPr>
                <a:xfrm>
                  <a:off x="5653800" y="1332000"/>
                  <a:ext cx="326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R5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41" name=""/>
              <p:cNvSpPr/>
              <p:nvPr/>
            </p:nvSpPr>
            <p:spPr>
              <a:xfrm flipH="1">
                <a:off x="4735080" y="1496880"/>
                <a:ext cx="188280" cy="0"/>
              </a:xfrm>
              <a:prstGeom prst="line">
                <a:avLst/>
              </a:prstGeom>
              <a:ln w="28440">
                <a:solidFill>
                  <a:srgbClr val="3366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4351320" y="901800"/>
                <a:ext cx="4010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 Narrow"/>
                  </a:rPr>
                  <a:t>R2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4511520" y="1133640"/>
                <a:ext cx="188640" cy="0"/>
              </a:xfrm>
              <a:prstGeom prst="line">
                <a:avLst/>
              </a:prstGeom>
              <a:ln w="28440">
                <a:solidFill>
                  <a:srgbClr val="3366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4708080" y="1476360"/>
                <a:ext cx="3268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 Narrow"/>
                  </a:rPr>
                  <a:t>R3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4566960" y="1628640"/>
                <a:ext cx="4014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 Narrow"/>
                  </a:rPr>
                  <a:t>B2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4714560" y="1851120"/>
                <a:ext cx="188640" cy="0"/>
              </a:xfrm>
              <a:prstGeom prst="line">
                <a:avLst/>
              </a:prstGeom>
              <a:ln w="28440">
                <a:solidFill>
                  <a:srgbClr val="cc33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47" name=""/>
              <p:cNvGrpSpPr/>
              <p:nvPr/>
            </p:nvGrpSpPr>
            <p:grpSpPr>
              <a:xfrm>
                <a:off x="3476160" y="1716120"/>
                <a:ext cx="2504520" cy="601200"/>
                <a:chOff x="3476160" y="1716120"/>
                <a:chExt cx="2504520" cy="601200"/>
              </a:xfrm>
            </p:grpSpPr>
            <p:sp>
              <p:nvSpPr>
                <p:cNvPr id="148" name=""/>
                <p:cNvSpPr/>
                <p:nvPr/>
              </p:nvSpPr>
              <p:spPr>
                <a:xfrm>
                  <a:off x="3568320" y="1943280"/>
                  <a:ext cx="236160" cy="0"/>
                </a:xfrm>
                <a:prstGeom prst="line">
                  <a:avLst/>
                </a:prstGeom>
                <a:ln w="2844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"/>
                <p:cNvSpPr/>
                <p:nvPr/>
              </p:nvSpPr>
              <p:spPr>
                <a:xfrm flipH="1">
                  <a:off x="5639760" y="2102040"/>
                  <a:ext cx="236160" cy="0"/>
                </a:xfrm>
                <a:prstGeom prst="line">
                  <a:avLst/>
                </a:prstGeom>
                <a:ln w="2844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"/>
                <p:cNvSpPr/>
                <p:nvPr/>
              </p:nvSpPr>
              <p:spPr>
                <a:xfrm>
                  <a:off x="3476160" y="1716120"/>
                  <a:ext cx="326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R0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"/>
                <p:cNvSpPr/>
                <p:nvPr/>
              </p:nvSpPr>
              <p:spPr>
                <a:xfrm>
                  <a:off x="5653800" y="2055960"/>
                  <a:ext cx="326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R5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152" name="Text Box 7"/>
            <p:cNvSpPr/>
            <p:nvPr/>
          </p:nvSpPr>
          <p:spPr>
            <a:xfrm>
              <a:off x="6001560" y="1009800"/>
              <a:ext cx="340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 Narrow"/>
                </a:rPr>
                <a:t>2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Text Box 8"/>
            <p:cNvSpPr/>
            <p:nvPr/>
          </p:nvSpPr>
          <p:spPr>
            <a:xfrm>
              <a:off x="6001560" y="890640"/>
              <a:ext cx="340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 Narrow"/>
                </a:rPr>
                <a:t>2.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Text Box 9"/>
            <p:cNvSpPr/>
            <p:nvPr/>
          </p:nvSpPr>
          <p:spPr>
            <a:xfrm>
              <a:off x="6001560" y="760680"/>
              <a:ext cx="340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 Narrow"/>
                </a:rPr>
                <a:t>3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Text Box 10"/>
            <p:cNvSpPr/>
            <p:nvPr/>
          </p:nvSpPr>
          <p:spPr>
            <a:xfrm>
              <a:off x="6001560" y="1509840"/>
              <a:ext cx="340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 Narrow"/>
                </a:rPr>
                <a:t>2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Text Box 11"/>
            <p:cNvSpPr/>
            <p:nvPr/>
          </p:nvSpPr>
          <p:spPr>
            <a:xfrm>
              <a:off x="6001560" y="1395720"/>
              <a:ext cx="340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 Narrow"/>
                </a:rPr>
                <a:t>2.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Text Box 12"/>
            <p:cNvSpPr/>
            <p:nvPr/>
          </p:nvSpPr>
          <p:spPr>
            <a:xfrm>
              <a:off x="6001560" y="1273320"/>
              <a:ext cx="340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 Narrow"/>
                </a:rPr>
                <a:t>3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Text Box 13"/>
            <p:cNvSpPr/>
            <p:nvPr/>
          </p:nvSpPr>
          <p:spPr>
            <a:xfrm>
              <a:off x="6001560" y="2552760"/>
              <a:ext cx="340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 Narrow"/>
                </a:rPr>
                <a:t>1.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Text Box 14"/>
            <p:cNvSpPr/>
            <p:nvPr/>
          </p:nvSpPr>
          <p:spPr>
            <a:xfrm>
              <a:off x="6001560" y="2417760"/>
              <a:ext cx="340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 Narrow"/>
                </a:rPr>
                <a:t>2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Text Box 15"/>
            <p:cNvSpPr/>
            <p:nvPr/>
          </p:nvSpPr>
          <p:spPr>
            <a:xfrm>
              <a:off x="6001560" y="2278080"/>
              <a:ext cx="340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 Narrow"/>
                </a:rPr>
                <a:t>2.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Text Box 18"/>
            <p:cNvSpPr/>
            <p:nvPr/>
          </p:nvSpPr>
          <p:spPr>
            <a:xfrm>
              <a:off x="6001560" y="2043360"/>
              <a:ext cx="340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 Narrow"/>
                </a:rPr>
                <a:t>1.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Text Box 19"/>
            <p:cNvSpPr/>
            <p:nvPr/>
          </p:nvSpPr>
          <p:spPr>
            <a:xfrm>
              <a:off x="6001560" y="1879920"/>
              <a:ext cx="340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 Narrow"/>
                </a:rPr>
                <a:t>2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Text Box 20"/>
            <p:cNvSpPr/>
            <p:nvPr/>
          </p:nvSpPr>
          <p:spPr>
            <a:xfrm>
              <a:off x="6001560" y="1733760"/>
              <a:ext cx="340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 Narrow"/>
                </a:rPr>
                <a:t>2.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Text Box 21"/>
            <p:cNvSpPr/>
            <p:nvPr/>
          </p:nvSpPr>
          <p:spPr>
            <a:xfrm>
              <a:off x="6001560" y="2694240"/>
              <a:ext cx="340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 Narrow"/>
                </a:rPr>
                <a:t>1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65" name="Picture 4" descr=""/>
            <p:cNvPicPr/>
            <p:nvPr/>
          </p:nvPicPr>
          <p:blipFill>
            <a:blip r:embed="rId5">
              <a:lum bright="8000"/>
            </a:blip>
            <a:srcRect l="23502" t="20924" r="69390" b="75307"/>
            <a:stretch/>
          </p:blipFill>
          <p:spPr>
            <a:xfrm>
              <a:off x="6342120" y="851040"/>
              <a:ext cx="566640" cy="369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6" name="Picture 22" descr=""/>
            <p:cNvPicPr/>
            <p:nvPr/>
          </p:nvPicPr>
          <p:blipFill>
            <a:blip r:embed="rId6">
              <a:lum bright="8000"/>
            </a:blip>
            <a:srcRect l="33696" t="20924" r="42831" b="75307"/>
            <a:stretch/>
          </p:blipFill>
          <p:spPr>
            <a:xfrm>
              <a:off x="6907320" y="851040"/>
              <a:ext cx="1874520" cy="369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7" name="Picture 5" descr=""/>
            <p:cNvPicPr/>
            <p:nvPr/>
          </p:nvPicPr>
          <p:blipFill>
            <a:blip r:embed="rId7"/>
            <a:srcRect l="22690" t="47610" r="70266" b="47481"/>
            <a:stretch/>
          </p:blipFill>
          <p:spPr>
            <a:xfrm>
              <a:off x="6343560" y="1273320"/>
              <a:ext cx="555480" cy="479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8" name="Picture 23" descr=""/>
            <p:cNvPicPr/>
            <p:nvPr/>
          </p:nvPicPr>
          <p:blipFill>
            <a:blip r:embed="rId8"/>
            <a:srcRect l="33509" t="47610" r="42467" b="47481"/>
            <a:stretch/>
          </p:blipFill>
          <p:spPr>
            <a:xfrm>
              <a:off x="6888240" y="1273320"/>
              <a:ext cx="1893600" cy="479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9" name="Picture 6" descr=""/>
            <p:cNvPicPr/>
            <p:nvPr/>
          </p:nvPicPr>
          <p:blipFill>
            <a:blip r:embed="rId9"/>
            <a:srcRect l="47787" t="39007" r="46126" b="52542"/>
            <a:stretch/>
          </p:blipFill>
          <p:spPr>
            <a:xfrm>
              <a:off x="6345000" y="2372040"/>
              <a:ext cx="560520" cy="533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0" name="Picture 24" descr=""/>
            <p:cNvPicPr/>
            <p:nvPr/>
          </p:nvPicPr>
          <p:blipFill>
            <a:blip r:embed="rId10"/>
            <a:srcRect l="56650" t="39007" r="22825" b="52542"/>
            <a:stretch/>
          </p:blipFill>
          <p:spPr>
            <a:xfrm>
              <a:off x="6902280" y="2372040"/>
              <a:ext cx="1886040" cy="533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1" name="Picture 17" descr=""/>
            <p:cNvPicPr/>
            <p:nvPr/>
          </p:nvPicPr>
          <p:blipFill>
            <a:blip r:embed="rId11">
              <a:lum bright="8000"/>
            </a:blip>
            <a:srcRect l="63624" t="55264" r="31182" b="35566"/>
            <a:stretch/>
          </p:blipFill>
          <p:spPr>
            <a:xfrm>
              <a:off x="6346800" y="1805040"/>
              <a:ext cx="558720" cy="505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2" name="Picture 25" descr=""/>
            <p:cNvPicPr/>
            <p:nvPr/>
          </p:nvPicPr>
          <p:blipFill>
            <a:blip r:embed="rId12">
              <a:lum bright="8000"/>
            </a:blip>
            <a:srcRect l="71335" t="55264" r="11089" b="35566"/>
            <a:stretch/>
          </p:blipFill>
          <p:spPr>
            <a:xfrm>
              <a:off x="6899040" y="1805040"/>
              <a:ext cx="1890720" cy="505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73" name="Text Box 29"/>
            <p:cNvSpPr/>
            <p:nvPr/>
          </p:nvSpPr>
          <p:spPr>
            <a:xfrm rot="16200000">
              <a:off x="6467760" y="441360"/>
              <a:ext cx="57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 Narrow"/>
                </a:rPr>
                <a:t>AR19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Text Box 30"/>
            <p:cNvSpPr/>
            <p:nvPr/>
          </p:nvSpPr>
          <p:spPr>
            <a:xfrm rot="16200000">
              <a:off x="6819120" y="512640"/>
              <a:ext cx="430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 Narrow"/>
                </a:rPr>
                <a:t>AR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Text Box 31"/>
            <p:cNvSpPr/>
            <p:nvPr/>
          </p:nvSpPr>
          <p:spPr>
            <a:xfrm rot="16200000">
              <a:off x="7155000" y="563400"/>
              <a:ext cx="32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333399"/>
                  </a:solidFill>
                  <a:latin typeface="Arial Narrow"/>
                </a:rPr>
                <a:t>T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Text Box 32"/>
            <p:cNvSpPr/>
            <p:nvPr/>
          </p:nvSpPr>
          <p:spPr>
            <a:xfrm rot="16200000">
              <a:off x="7365960" y="530280"/>
              <a:ext cx="397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333399"/>
                  </a:solidFill>
                  <a:latin typeface="Arial Narrow"/>
                </a:rPr>
                <a:t>T1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Text Box 33"/>
            <p:cNvSpPr/>
            <p:nvPr/>
          </p:nvSpPr>
          <p:spPr>
            <a:xfrm rot="16200000">
              <a:off x="7654320" y="535320"/>
              <a:ext cx="340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cc3300"/>
                  </a:solidFill>
                  <a:latin typeface="Arial Narrow"/>
                </a:rPr>
                <a:t>H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Text Box 34"/>
            <p:cNvSpPr/>
            <p:nvPr/>
          </p:nvSpPr>
          <p:spPr>
            <a:xfrm rot="16200000">
              <a:off x="7892280" y="505080"/>
              <a:ext cx="410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cc3300"/>
                  </a:solidFill>
                  <a:latin typeface="Arial Narrow"/>
                </a:rPr>
                <a:t>H2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Text Box 35"/>
            <p:cNvSpPr/>
            <p:nvPr/>
          </p:nvSpPr>
          <p:spPr>
            <a:xfrm rot="16200000">
              <a:off x="8203320" y="550080"/>
              <a:ext cx="340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336600"/>
                  </a:solidFill>
                  <a:latin typeface="Arial Narrow"/>
                </a:rPr>
                <a:t>C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Text Box 36"/>
            <p:cNvSpPr/>
            <p:nvPr/>
          </p:nvSpPr>
          <p:spPr>
            <a:xfrm rot="16200000">
              <a:off x="8421120" y="524160"/>
              <a:ext cx="410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336600"/>
                  </a:solidFill>
                  <a:latin typeface="Arial Narrow"/>
                </a:rPr>
                <a:t>C3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Text Box 37"/>
            <p:cNvSpPr/>
            <p:nvPr/>
          </p:nvSpPr>
          <p:spPr>
            <a:xfrm>
              <a:off x="6375960" y="576360"/>
              <a:ext cx="284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 Narrow"/>
                </a:rPr>
                <a:t>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Text Box 38"/>
            <p:cNvSpPr/>
            <p:nvPr/>
          </p:nvSpPr>
          <p:spPr>
            <a:xfrm>
              <a:off x="5984280" y="592200"/>
              <a:ext cx="315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 Narrow"/>
                </a:rPr>
                <a:t>kb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Text Box 41"/>
            <p:cNvSpPr/>
            <p:nvPr/>
          </p:nvSpPr>
          <p:spPr>
            <a:xfrm>
              <a:off x="8750160" y="917640"/>
              <a:ext cx="1044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 Narrow"/>
                </a:rPr>
                <a:t>R0-R1: 2.25 k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Text Box 42"/>
            <p:cNvSpPr/>
            <p:nvPr/>
          </p:nvSpPr>
          <p:spPr>
            <a:xfrm>
              <a:off x="8750160" y="1374840"/>
              <a:ext cx="1044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 Narrow"/>
                </a:rPr>
                <a:t>R0-B1: 2.61 k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Text Box 43"/>
            <p:cNvSpPr/>
            <p:nvPr/>
          </p:nvSpPr>
          <p:spPr>
            <a:xfrm>
              <a:off x="8750160" y="1906560"/>
              <a:ext cx="1044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 Narrow"/>
                </a:rPr>
                <a:t>B2-R5: 1.83 k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Text Box 44"/>
            <p:cNvSpPr/>
            <p:nvPr/>
          </p:nvSpPr>
          <p:spPr>
            <a:xfrm>
              <a:off x="8767440" y="2487600"/>
              <a:ext cx="1044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 Narrow"/>
                </a:rPr>
                <a:t>R2-R3: 1.74 k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87" name="Picture 6" descr="C:\Users\Ester\Documents\IATA\RC6\Fotos MUR disruptos &amp; complementados\20121102_082722.jpg"/>
            <p:cNvPicPr/>
            <p:nvPr/>
          </p:nvPicPr>
          <p:blipFill>
            <a:blip r:embed="rId13"/>
            <a:srcRect l="12736" t="4741" r="13271" b="52014"/>
            <a:stretch/>
          </p:blipFill>
          <p:spPr>
            <a:xfrm>
              <a:off x="8381880" y="3524400"/>
              <a:ext cx="1359000" cy="595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88" name=""/>
            <p:cNvSpPr/>
            <p:nvPr/>
          </p:nvSpPr>
          <p:spPr>
            <a:xfrm>
              <a:off x="8761680" y="3289320"/>
              <a:ext cx="57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 Narrow"/>
                </a:rPr>
                <a:t>AR23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8499600" y="4111920"/>
              <a:ext cx="340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 Narrow"/>
                </a:rPr>
                <a:t>C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8817120" y="4111920"/>
              <a:ext cx="410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 Narrow"/>
                </a:rPr>
                <a:t>C3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9185400" y="4111920"/>
              <a:ext cx="410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 Narrow"/>
                </a:rPr>
                <a:t>C3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7202520" y="422280"/>
              <a:ext cx="990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7391520" y="162000"/>
              <a:ext cx="617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0" i="1" lang="en-GB" sz="1400" spc="-1" strike="noStrike">
                  <a:solidFill>
                    <a:srgbClr val="000000"/>
                  </a:solidFill>
                  <a:latin typeface="Arial Narrow"/>
                </a:rPr>
                <a:t>rha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MARGA</cp:lastModifiedBy>
  <dcterms:modified xsi:type="dcterms:W3CDTF">2014-10-27T09:41:44Z</dcterms:modified>
  <cp:revision>31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